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86" d="100"/>
          <a:sy n="86" d="100"/>
        </p:scale>
        <p:origin x="654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9A10C4-3F46-452C-8E1B-9EF8883B46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E081FD0-70EA-4FF1-8DA3-375FDE60C0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F862660-88ED-422C-BCE3-15C02EAD5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5099C86-17DE-4991-A5DD-63E51808D7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1079A19-0D9C-4D9F-BE8E-22D9637106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309487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9A212E-AC5B-43AD-81B8-E76E9A7E3E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DE1148-CA93-44E4-B06B-5C5CBFE6811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BB2D257-A97B-4423-A337-7E201FCA0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35BE826-1E2F-4AA7-A74A-FA8159700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3B20BDE-1978-4BC6-8C6C-2AB2356024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2039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28BE5F1-AD61-47EC-ABAC-601C8F57779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1310F08-3278-4012-BE6B-C9FA5D0A0F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615608D-DAA2-43AF-BD02-7082EB0F2E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BE69EB3-4744-414F-8B2B-B1BF60DDD3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686E69-CF12-4A0F-8DF6-EA4F527FB3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693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E27FC06-6936-4F83-B02B-77E3878E93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85B4D3C-6F5D-43F5-95EB-54E1FB0A0D9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0F4598-479D-48E8-AACF-417D71735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0101DC7-B6E0-461F-9FF7-AFE334A2C4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55BD080-61E3-4045-BC58-B776D24F4A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09000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F7996C-ED32-43E1-B25C-7D61B24F1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FC7C15-4B2E-4D57-A4E8-A10C7442D2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04A932A-667B-49BF-9CDF-7052452513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A06666D-52A1-4423-84CA-9E03921429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9FD0ACE-45DD-4666-8E4F-4E6524D4C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90552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CAE29B-D9E2-4092-B9AD-3384DEE0A9D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DD79E061-16C7-4F5C-BB82-80C9CFD8C48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3397B72-50B4-4142-8541-A5700EF081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5570CA-1D4F-4368-85F8-3AD79246DC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E2788CD-E54A-4A40-808A-8BFEA7AC66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D42DA99-77F6-4DAC-84AC-71AB1F6C8B8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221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EAE0BE-27D9-4454-9A26-0EA5F46641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FE19F9C-5658-4343-B699-C5ADF5DC75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D4B98FC-78DD-4D82-B33B-DC10C3CA31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2D59AD59-9FBC-4686-8BA1-B062897D580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B893F91-DEC9-44C9-86D4-5C41493D03F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61A3044-21E8-4148-8D34-318514439A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5A5239F-78FD-4D3C-B82C-8030E7C0AC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06BA073-05FE-4C08-9362-4B808E94BC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70933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56C8F1-1513-4E40-B840-9A419ABFE6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E5D8471-A8B3-4342-9EC0-76AD327E67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4EE6133-60C9-4610-8CF4-87C0318BE7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599B03A-869F-4AA8-9DF4-95795DE8F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7909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266BF4E-CA4C-43D3-A4C0-CA801607F6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E03D79C-A668-49BB-9B58-39471CFFFD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0FD11FD-A639-476F-A66F-098A6538F6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3089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39632C-4815-488E-A227-1689D5D2D1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942D4FC6-2826-4B6A-94D3-215F465C34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2793B7B-7ABE-43EA-A77D-AABFF72748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FA2AD7F-AB42-4448-B850-FEA8D88B7E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B0BE17E-EAFB-4081-952C-FDA5574588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097DA2F-5169-49FD-ABFC-475DA89234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748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9923710-CF83-408C-AB26-2AA9DDB83F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176E3AF-78CF-449B-BF84-A0E981AB346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77F00C4-3D81-4A6F-A291-51F6E455CF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BC28E09-88BF-456D-B726-B6D4A9DE6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0EE2A9C-355E-45D2-B3DE-7AB099AF8A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CA19F1-D3A8-4AD4-9CDB-FC2DA6FBD0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91600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D9583CFE-CC13-4E3F-8F3B-97ED318920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0EB6E57-BB8D-4DB7-B383-24A4E6E757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32A1873-21CA-4492-82E6-BF86702D7D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F36E2-5061-4DDD-ADF6-5A5D7FCF82BC}" type="datetimeFigureOut">
              <a:rPr lang="zh-CN" altLang="en-US" smtClean="0"/>
              <a:t>2022/6/29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D97BF70-0E38-4E95-8747-064CDFEF4EE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57B6C21-2F09-433C-A791-D0811D22F94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CC4FE3-E68A-470D-8CAF-57660837B4E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0906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oup 4">
            <a:extLst>
              <a:ext uri="{FF2B5EF4-FFF2-40B4-BE49-F238E27FC236}">
                <a16:creationId xmlns:a16="http://schemas.microsoft.com/office/drawing/2014/main" id="{755FAA11-EDCB-45C7-BFA4-0EBCE4777A51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890838" y="2709863"/>
            <a:ext cx="5884862" cy="1466850"/>
            <a:chOff x="1821" y="1707"/>
            <a:chExt cx="3707" cy="924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98C05AE7-3216-4F07-8F90-1E05740160F4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821" y="1707"/>
              <a:ext cx="3707" cy="92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Oval 5">
              <a:extLst>
                <a:ext uri="{FF2B5EF4-FFF2-40B4-BE49-F238E27FC236}">
                  <a16:creationId xmlns:a16="http://schemas.microsoft.com/office/drawing/2014/main" id="{EE5482B6-EF2C-4883-B08C-FD674C5F14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" y="1794"/>
              <a:ext cx="751" cy="277"/>
            </a:xfrm>
            <a:prstGeom prst="ellipse">
              <a:avLst/>
            </a:prstGeom>
            <a:solidFill>
              <a:srgbClr val="B7DDE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Oval 6">
              <a:extLst>
                <a:ext uri="{FF2B5EF4-FFF2-40B4-BE49-F238E27FC236}">
                  <a16:creationId xmlns:a16="http://schemas.microsoft.com/office/drawing/2014/main" id="{BD7A57DB-E2CC-4AF5-B638-2E47EA7201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" y="1794"/>
              <a:ext cx="751" cy="277"/>
            </a:xfrm>
            <a:prstGeom prst="ellips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C3D166EC-DCC5-4466-A948-0D1E20D686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7" y="1801"/>
              <a:ext cx="160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O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E67AC170-CEA7-49AC-B9C1-47C1EF3F2F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45" y="1801"/>
              <a:ext cx="32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igina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08552775-F586-4710-9C70-9C76260A46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85" y="1935"/>
              <a:ext cx="298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ign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Oval 10">
              <a:extLst>
                <a:ext uri="{FF2B5EF4-FFF2-40B4-BE49-F238E27FC236}">
                  <a16:creationId xmlns:a16="http://schemas.microsoft.com/office/drawing/2014/main" id="{B16FC8C3-E22C-404E-9024-836F8CE6D6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" y="2295"/>
              <a:ext cx="751" cy="277"/>
            </a:xfrm>
            <a:prstGeom prst="ellipse">
              <a:avLst/>
            </a:prstGeom>
            <a:solidFill>
              <a:srgbClr val="AB9AC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4" name="Oval 11">
              <a:extLst>
                <a:ext uri="{FF2B5EF4-FFF2-40B4-BE49-F238E27FC236}">
                  <a16:creationId xmlns:a16="http://schemas.microsoft.com/office/drawing/2014/main" id="{D727CCFF-7E99-47D0-AF74-609299A813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30" y="2295"/>
              <a:ext cx="751" cy="277"/>
            </a:xfrm>
            <a:prstGeom prst="ellips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43F78996-D87F-491D-9485-6459D84657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20" y="2368"/>
              <a:ext cx="104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018771EB-E103-4E7D-A5D9-2E119B8902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77" y="2368"/>
              <a:ext cx="601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eprocessing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Oval 14">
              <a:extLst>
                <a:ext uri="{FF2B5EF4-FFF2-40B4-BE49-F238E27FC236}">
                  <a16:creationId xmlns:a16="http://schemas.microsoft.com/office/drawing/2014/main" id="{D2C7FCC6-0EE7-4532-82EF-1C6335F75A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" y="2295"/>
              <a:ext cx="751" cy="277"/>
            </a:xfrm>
            <a:prstGeom prst="ellipse">
              <a:avLst/>
            </a:prstGeom>
            <a:solidFill>
              <a:srgbClr val="D8D8D8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8" name="Oval 15">
              <a:extLst>
                <a:ext uri="{FF2B5EF4-FFF2-40B4-BE49-F238E27FC236}">
                  <a16:creationId xmlns:a16="http://schemas.microsoft.com/office/drawing/2014/main" id="{5FBD2380-2611-4D7D-BBFC-CC4BDB18C4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" y="2295"/>
              <a:ext cx="751" cy="277"/>
            </a:xfrm>
            <a:prstGeom prst="ellips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C2A98568-15E9-4B5B-89EE-F0774C4494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6" y="2302"/>
              <a:ext cx="403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Feature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5C80B704-532F-45D7-A559-DCAB656EDDE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5" y="2436"/>
              <a:ext cx="463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xtrac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Oval 18">
              <a:extLst>
                <a:ext uri="{FF2B5EF4-FFF2-40B4-BE49-F238E27FC236}">
                  <a16:creationId xmlns:a16="http://schemas.microsoft.com/office/drawing/2014/main" id="{BE31FA74-F677-4383-9314-9B9904790C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" y="1731"/>
              <a:ext cx="751" cy="403"/>
            </a:xfrm>
            <a:prstGeom prst="ellipse">
              <a:avLst/>
            </a:prstGeom>
            <a:solidFill>
              <a:srgbClr val="D7E3BF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2" name="Oval 19">
              <a:extLst>
                <a:ext uri="{FF2B5EF4-FFF2-40B4-BE49-F238E27FC236}">
                  <a16:creationId xmlns:a16="http://schemas.microsoft.com/office/drawing/2014/main" id="{123F2B33-2B3A-482E-8B2E-AE20935972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842" y="1731"/>
              <a:ext cx="751" cy="403"/>
            </a:xfrm>
            <a:prstGeom prst="ellips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02EA6727-AD06-46F1-AE15-562FBC7ADE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7" y="1744"/>
              <a:ext cx="414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odel 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F812DEB7-4B82-4B47-ACA8-7CD5C01C2B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47" y="1877"/>
              <a:ext cx="348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ode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30BAFB21-FB11-4FDB-9661-87AC7B8E19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42" y="1877"/>
              <a:ext cx="99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A5D326BE-A357-4FA5-81BD-2079974694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7" y="2013"/>
              <a:ext cx="100" cy="1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2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...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8090B8AE-41B7-4501-9309-7111AA86D3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" y="1731"/>
              <a:ext cx="834" cy="89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49784309-9D08-4C0B-8549-1E8F4A3C73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07" y="1731"/>
              <a:ext cx="834" cy="895"/>
            </a:xfrm>
            <a:prstGeom prst="rect">
              <a:avLst/>
            </a:prstGeom>
            <a:noFill/>
            <a:ln w="3175" cap="rnd">
              <a:solidFill>
                <a:srgbClr val="FFC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CA52494B-1538-43A6-93EE-D1B221938B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1" y="1794"/>
              <a:ext cx="626" cy="277"/>
            </a:xfrm>
            <a:prstGeom prst="rect">
              <a:avLst/>
            </a:prstGeom>
            <a:solidFill>
              <a:srgbClr val="FBD7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A7F1CDB0-5022-43CE-8C04-21F7182835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1" y="1794"/>
              <a:ext cx="626" cy="277"/>
            </a:xfrm>
            <a:prstGeom prst="rect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C64901F5-633F-4C9A-8CDC-73E25CF70E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2" y="1801"/>
              <a:ext cx="143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34E85757-9813-45B8-A763-0D1C0A0512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4" y="1801"/>
              <a:ext cx="259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odel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759BE627-4D55-45AB-A41C-A7C84C5E86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3" y="1935"/>
              <a:ext cx="420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selectio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3EB51F1D-91E2-49A6-B93C-73B6B0A1322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1" y="2295"/>
              <a:ext cx="626" cy="277"/>
            </a:xfrm>
            <a:prstGeom prst="rect">
              <a:avLst/>
            </a:prstGeom>
            <a:solidFill>
              <a:srgbClr val="FBD7BB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C0D90126-AA86-47CF-88BA-A7F55D2FDD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1" y="2295"/>
              <a:ext cx="626" cy="277"/>
            </a:xfrm>
            <a:prstGeom prst="rect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6D496288-44F3-4890-AD85-7BE9E7F08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8" y="2302"/>
              <a:ext cx="11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R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C8C898B2-92CC-49AD-967A-744183E87B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" y="2302"/>
              <a:ext cx="446" cy="15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ference 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35A5CD98-29FD-478E-ABDB-DE16018F88F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8" y="2436"/>
              <a:ext cx="309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mode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Oval 36">
              <a:extLst>
                <a:ext uri="{FF2B5EF4-FFF2-40B4-BE49-F238E27FC236}">
                  <a16:creationId xmlns:a16="http://schemas.microsoft.com/office/drawing/2014/main" id="{9D4157ED-92E7-42CF-A85D-B8DCB53D9B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0" y="1977"/>
              <a:ext cx="751" cy="277"/>
            </a:xfrm>
            <a:prstGeom prst="ellipse">
              <a:avLst/>
            </a:prstGeom>
            <a:solidFill>
              <a:srgbClr val="92CDDC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0" name="Oval 37">
              <a:extLst>
                <a:ext uri="{FF2B5EF4-FFF2-40B4-BE49-F238E27FC236}">
                  <a16:creationId xmlns:a16="http://schemas.microsoft.com/office/drawing/2014/main" id="{E9B55098-AC21-4293-BCAD-E101E84526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0" y="1977"/>
              <a:ext cx="751" cy="277"/>
            </a:xfrm>
            <a:prstGeom prst="ellipse">
              <a:avLst/>
            </a:prstGeom>
            <a:noFill/>
            <a:ln w="317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B733A9DA-C3C0-4CFF-906E-1508415C15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54" y="2051"/>
              <a:ext cx="116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B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A398ABA7-05A2-4A9C-AF47-88F3C15783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22" y="2051"/>
              <a:ext cx="166" cy="16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1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</a:rPr>
                <a:t>ea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Line 40">
              <a:extLst>
                <a:ext uri="{FF2B5EF4-FFF2-40B4-BE49-F238E27FC236}">
                  <a16:creationId xmlns:a16="http://schemas.microsoft.com/office/drawing/2014/main" id="{C9BFE125-EC12-480D-A08B-3D59E7A792E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06" y="2071"/>
              <a:ext cx="0" cy="173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4" name="Freeform 41">
              <a:extLst>
                <a:ext uri="{FF2B5EF4-FFF2-40B4-BE49-F238E27FC236}">
                  <a16:creationId xmlns:a16="http://schemas.microsoft.com/office/drawing/2014/main" id="{91CDAFBB-6E13-4577-96D9-251C89ADCB05}"/>
                </a:ext>
              </a:extLst>
            </p:cNvPr>
            <p:cNvSpPr>
              <a:spLocks/>
            </p:cNvSpPr>
            <p:nvPr/>
          </p:nvSpPr>
          <p:spPr bwMode="auto">
            <a:xfrm>
              <a:off x="2182" y="2235"/>
              <a:ext cx="48" cy="60"/>
            </a:xfrm>
            <a:custGeom>
              <a:avLst/>
              <a:gdLst>
                <a:gd name="T0" fmla="*/ 139 w 139"/>
                <a:gd name="T1" fmla="*/ 22 h 162"/>
                <a:gd name="T2" fmla="*/ 70 w 139"/>
                <a:gd name="T3" fmla="*/ 162 h 162"/>
                <a:gd name="T4" fmla="*/ 0 w 139"/>
                <a:gd name="T5" fmla="*/ 22 h 162"/>
                <a:gd name="T6" fmla="*/ 139 w 139"/>
                <a:gd name="T7" fmla="*/ 22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39" h="162">
                  <a:moveTo>
                    <a:pt x="139" y="22"/>
                  </a:moveTo>
                  <a:lnTo>
                    <a:pt x="70" y="162"/>
                  </a:lnTo>
                  <a:lnTo>
                    <a:pt x="0" y="22"/>
                  </a:lnTo>
                  <a:cubicBezTo>
                    <a:pt x="44" y="0"/>
                    <a:pt x="95" y="0"/>
                    <a:pt x="139" y="22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5" name="Line 42">
              <a:extLst>
                <a:ext uri="{FF2B5EF4-FFF2-40B4-BE49-F238E27FC236}">
                  <a16:creationId xmlns:a16="http://schemas.microsoft.com/office/drawing/2014/main" id="{3BF12E55-9743-4C13-8F67-CECEF652283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1" y="2433"/>
              <a:ext cx="224" cy="27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6" name="Freeform 43">
              <a:extLst>
                <a:ext uri="{FF2B5EF4-FFF2-40B4-BE49-F238E27FC236}">
                  <a16:creationId xmlns:a16="http://schemas.microsoft.com/office/drawing/2014/main" id="{D87FDE84-CD1A-48DC-9EA4-1E0E090C7A45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7" y="2434"/>
              <a:ext cx="56" cy="52"/>
            </a:xfrm>
            <a:custGeom>
              <a:avLst/>
              <a:gdLst>
                <a:gd name="T0" fmla="*/ 32 w 163"/>
                <a:gd name="T1" fmla="*/ 0 h 139"/>
                <a:gd name="T2" fmla="*/ 163 w 163"/>
                <a:gd name="T3" fmla="*/ 85 h 139"/>
                <a:gd name="T4" fmla="*/ 17 w 163"/>
                <a:gd name="T5" fmla="*/ 139 h 139"/>
                <a:gd name="T6" fmla="*/ 32 w 163"/>
                <a:gd name="T7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3" h="139">
                  <a:moveTo>
                    <a:pt x="32" y="0"/>
                  </a:moveTo>
                  <a:lnTo>
                    <a:pt x="163" y="85"/>
                  </a:lnTo>
                  <a:lnTo>
                    <a:pt x="17" y="139"/>
                  </a:lnTo>
                  <a:cubicBezTo>
                    <a:pt x="0" y="93"/>
                    <a:pt x="6" y="41"/>
                    <a:pt x="32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7" name="Line 44">
              <a:extLst>
                <a:ext uri="{FF2B5EF4-FFF2-40B4-BE49-F238E27FC236}">
                  <a16:creationId xmlns:a16="http://schemas.microsoft.com/office/drawing/2014/main" id="{B5F8F0E7-5679-46E1-A145-327BD783866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218" y="2185"/>
              <a:ext cx="0" cy="11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8" name="Freeform 45">
              <a:extLst>
                <a:ext uri="{FF2B5EF4-FFF2-40B4-BE49-F238E27FC236}">
                  <a16:creationId xmlns:a16="http://schemas.microsoft.com/office/drawing/2014/main" id="{834DAF5F-205C-42B8-A2A0-50DB66F4968E}"/>
                </a:ext>
              </a:extLst>
            </p:cNvPr>
            <p:cNvSpPr>
              <a:spLocks/>
            </p:cNvSpPr>
            <p:nvPr/>
          </p:nvSpPr>
          <p:spPr bwMode="auto">
            <a:xfrm>
              <a:off x="3194" y="2134"/>
              <a:ext cx="48" cy="60"/>
            </a:xfrm>
            <a:custGeom>
              <a:avLst/>
              <a:gdLst>
                <a:gd name="T0" fmla="*/ 0 w 140"/>
                <a:gd name="T1" fmla="*/ 140 h 162"/>
                <a:gd name="T2" fmla="*/ 70 w 140"/>
                <a:gd name="T3" fmla="*/ 0 h 162"/>
                <a:gd name="T4" fmla="*/ 140 w 140"/>
                <a:gd name="T5" fmla="*/ 140 h 162"/>
                <a:gd name="T6" fmla="*/ 0 w 140"/>
                <a:gd name="T7" fmla="*/ 140 h 1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40" h="162">
                  <a:moveTo>
                    <a:pt x="0" y="140"/>
                  </a:moveTo>
                  <a:lnTo>
                    <a:pt x="70" y="0"/>
                  </a:lnTo>
                  <a:lnTo>
                    <a:pt x="140" y="140"/>
                  </a:lnTo>
                  <a:cubicBezTo>
                    <a:pt x="96" y="162"/>
                    <a:pt x="44" y="162"/>
                    <a:pt x="0" y="14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49" name="Line 46">
              <a:extLst>
                <a:ext uri="{FF2B5EF4-FFF2-40B4-BE49-F238E27FC236}">
                  <a16:creationId xmlns:a16="http://schemas.microsoft.com/office/drawing/2014/main" id="{A6F61E57-7568-4556-9055-1FFAE29AC00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93" y="1932"/>
              <a:ext cx="93" cy="20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0" name="Freeform 47">
              <a:extLst>
                <a:ext uri="{FF2B5EF4-FFF2-40B4-BE49-F238E27FC236}">
                  <a16:creationId xmlns:a16="http://schemas.microsoft.com/office/drawing/2014/main" id="{D068875D-D291-45E5-BE23-A2D8051D4660}"/>
                </a:ext>
              </a:extLst>
            </p:cNvPr>
            <p:cNvSpPr>
              <a:spLocks/>
            </p:cNvSpPr>
            <p:nvPr/>
          </p:nvSpPr>
          <p:spPr bwMode="auto">
            <a:xfrm>
              <a:off x="3664" y="2121"/>
              <a:ext cx="43" cy="58"/>
            </a:xfrm>
            <a:custGeom>
              <a:avLst/>
              <a:gdLst>
                <a:gd name="T0" fmla="*/ 125 w 125"/>
                <a:gd name="T1" fmla="*/ 0 h 156"/>
                <a:gd name="T2" fmla="*/ 125 w 125"/>
                <a:gd name="T3" fmla="*/ 156 h 156"/>
                <a:gd name="T4" fmla="*/ 0 w 125"/>
                <a:gd name="T5" fmla="*/ 62 h 156"/>
                <a:gd name="T6" fmla="*/ 125 w 125"/>
                <a:gd name="T7" fmla="*/ 0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25" h="156">
                  <a:moveTo>
                    <a:pt x="125" y="0"/>
                  </a:moveTo>
                  <a:lnTo>
                    <a:pt x="125" y="156"/>
                  </a:lnTo>
                  <a:lnTo>
                    <a:pt x="0" y="62"/>
                  </a:lnTo>
                  <a:cubicBezTo>
                    <a:pt x="30" y="23"/>
                    <a:pt x="76" y="0"/>
                    <a:pt x="125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1" name="Line 48">
              <a:extLst>
                <a:ext uri="{FF2B5EF4-FFF2-40B4-BE49-F238E27FC236}">
                  <a16:creationId xmlns:a16="http://schemas.microsoft.com/office/drawing/2014/main" id="{51CC8B83-6337-48A4-B37B-70C84675BCE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41" y="2128"/>
              <a:ext cx="183" cy="51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2" name="Freeform 49">
              <a:extLst>
                <a:ext uri="{FF2B5EF4-FFF2-40B4-BE49-F238E27FC236}">
                  <a16:creationId xmlns:a16="http://schemas.microsoft.com/office/drawing/2014/main" id="{1890D634-DD3D-45F4-941C-1127111155F2}"/>
                </a:ext>
              </a:extLst>
            </p:cNvPr>
            <p:cNvSpPr>
              <a:spLocks/>
            </p:cNvSpPr>
            <p:nvPr/>
          </p:nvSpPr>
          <p:spPr bwMode="auto">
            <a:xfrm>
              <a:off x="4714" y="2104"/>
              <a:ext cx="56" cy="50"/>
            </a:xfrm>
            <a:custGeom>
              <a:avLst/>
              <a:gdLst>
                <a:gd name="T0" fmla="*/ 10 w 163"/>
                <a:gd name="T1" fmla="*/ 0 h 135"/>
                <a:gd name="T2" fmla="*/ 163 w 163"/>
                <a:gd name="T3" fmla="*/ 33 h 135"/>
                <a:gd name="T4" fmla="*/ 45 w 163"/>
                <a:gd name="T5" fmla="*/ 135 h 135"/>
                <a:gd name="T6" fmla="*/ 10 w 163"/>
                <a:gd name="T7" fmla="*/ 0 h 13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3" h="135">
                  <a:moveTo>
                    <a:pt x="10" y="0"/>
                  </a:moveTo>
                  <a:lnTo>
                    <a:pt x="163" y="33"/>
                  </a:lnTo>
                  <a:lnTo>
                    <a:pt x="45" y="135"/>
                  </a:lnTo>
                  <a:cubicBezTo>
                    <a:pt x="13" y="98"/>
                    <a:pt x="0" y="48"/>
                    <a:pt x="10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3" name="Line 50">
              <a:extLst>
                <a:ext uri="{FF2B5EF4-FFF2-40B4-BE49-F238E27FC236}">
                  <a16:creationId xmlns:a16="http://schemas.microsoft.com/office/drawing/2014/main" id="{888188F7-D229-4DF5-B4F9-64C4B59DE5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81" y="2433"/>
              <a:ext cx="214" cy="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4" name="Freeform 51">
              <a:extLst>
                <a:ext uri="{FF2B5EF4-FFF2-40B4-BE49-F238E27FC236}">
                  <a16:creationId xmlns:a16="http://schemas.microsoft.com/office/drawing/2014/main" id="{D7E7DB94-3173-4463-AA99-214B9A2E25A4}"/>
                </a:ext>
              </a:extLst>
            </p:cNvPr>
            <p:cNvSpPr>
              <a:spLocks/>
            </p:cNvSpPr>
            <p:nvPr/>
          </p:nvSpPr>
          <p:spPr bwMode="auto">
            <a:xfrm>
              <a:off x="2787" y="2408"/>
              <a:ext cx="55" cy="51"/>
            </a:xfrm>
            <a:custGeom>
              <a:avLst/>
              <a:gdLst>
                <a:gd name="T0" fmla="*/ 22 w 161"/>
                <a:gd name="T1" fmla="*/ 0 h 140"/>
                <a:gd name="T2" fmla="*/ 161 w 161"/>
                <a:gd name="T3" fmla="*/ 70 h 140"/>
                <a:gd name="T4" fmla="*/ 22 w 161"/>
                <a:gd name="T5" fmla="*/ 140 h 140"/>
                <a:gd name="T6" fmla="*/ 22 w 161"/>
                <a:gd name="T7" fmla="*/ 0 h 1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1" h="140">
                  <a:moveTo>
                    <a:pt x="22" y="0"/>
                  </a:moveTo>
                  <a:lnTo>
                    <a:pt x="161" y="70"/>
                  </a:lnTo>
                  <a:lnTo>
                    <a:pt x="22" y="140"/>
                  </a:lnTo>
                  <a:cubicBezTo>
                    <a:pt x="0" y="96"/>
                    <a:pt x="0" y="44"/>
                    <a:pt x="22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5" name="Line 52">
              <a:extLst>
                <a:ext uri="{FF2B5EF4-FFF2-40B4-BE49-F238E27FC236}">
                  <a16:creationId xmlns:a16="http://schemas.microsoft.com/office/drawing/2014/main" id="{C565D29B-7F4E-4616-BA14-4258F9812A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81" y="2403"/>
              <a:ext cx="227" cy="30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56" name="Freeform 53">
              <a:extLst>
                <a:ext uri="{FF2B5EF4-FFF2-40B4-BE49-F238E27FC236}">
                  <a16:creationId xmlns:a16="http://schemas.microsoft.com/office/drawing/2014/main" id="{5267FF01-4FC1-4031-867D-BA6B1C654281}"/>
                </a:ext>
              </a:extLst>
            </p:cNvPr>
            <p:cNvSpPr>
              <a:spLocks/>
            </p:cNvSpPr>
            <p:nvPr/>
          </p:nvSpPr>
          <p:spPr bwMode="auto">
            <a:xfrm>
              <a:off x="2799" y="2378"/>
              <a:ext cx="56" cy="51"/>
            </a:xfrm>
            <a:custGeom>
              <a:avLst/>
              <a:gdLst>
                <a:gd name="T0" fmla="*/ 16 w 163"/>
                <a:gd name="T1" fmla="*/ 0 h 138"/>
                <a:gd name="T2" fmla="*/ 163 w 163"/>
                <a:gd name="T3" fmla="*/ 52 h 138"/>
                <a:gd name="T4" fmla="*/ 33 w 163"/>
                <a:gd name="T5" fmla="*/ 138 h 138"/>
                <a:gd name="T6" fmla="*/ 16 w 163"/>
                <a:gd name="T7" fmla="*/ 0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</a:cxnLst>
              <a:rect l="0" t="0" r="r" b="b"/>
              <a:pathLst>
                <a:path w="163" h="138">
                  <a:moveTo>
                    <a:pt x="16" y="0"/>
                  </a:moveTo>
                  <a:lnTo>
                    <a:pt x="163" y="52"/>
                  </a:lnTo>
                  <a:lnTo>
                    <a:pt x="33" y="138"/>
                  </a:lnTo>
                  <a:cubicBezTo>
                    <a:pt x="6" y="97"/>
                    <a:pt x="0" y="46"/>
                    <a:pt x="16" y="0"/>
                  </a:cubicBez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898655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2</Words>
  <Application>Microsoft Office PowerPoint</Application>
  <PresentationFormat>宽屏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Think</cp:lastModifiedBy>
  <cp:revision>2</cp:revision>
  <dcterms:created xsi:type="dcterms:W3CDTF">2022-06-29T02:53:25Z</dcterms:created>
  <dcterms:modified xsi:type="dcterms:W3CDTF">2022-06-29T02:53:31Z</dcterms:modified>
</cp:coreProperties>
</file>